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upvehueus-my.sharepoint.com/personal/veronica_torrano_ehu_eus/Documents/Manuscripts_VT/Schaub_et_al_March24/JOURNAL_SUBMISSIONS/CellDeath&amp;Diff/RevisionCDDis/Xenos%20SRM%20Analysis%20(1)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pvehueus-my.sharepoint.com/personal/veronica_torrano_ehu_eus/Documents/Manuscripts_VT/Schaub_et_al_March24/JOURNAL_SUBMISSIONS/CellDeath&amp;Diff/RevisionCDDis/Xenos%20SRM%20Analysis%20(1)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ollow up wo outliers'!$P$112</c:f>
              <c:strCache>
                <c:ptCount val="1"/>
                <c:pt idx="0">
                  <c:v>PC3 PGC1A Clover Ctrl No Dox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stdErr"/>
            <c:noEndCap val="0"/>
          </c:errBars>
          <c:cat>
            <c:numRef>
              <c:f>'follow up wo outliers'!$Q$111:$V$111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3</c:v>
                </c:pt>
                <c:pt idx="5">
                  <c:v>16</c:v>
                </c:pt>
              </c:numCache>
            </c:numRef>
          </c:cat>
          <c:val>
            <c:numRef>
              <c:f>'follow up wo outliers'!$Q$112:$V$112</c:f>
              <c:numCache>
                <c:formatCode>0.00E+00</c:formatCode>
                <c:ptCount val="6"/>
                <c:pt idx="0">
                  <c:v>1</c:v>
                </c:pt>
                <c:pt idx="1">
                  <c:v>4.708618258995088</c:v>
                </c:pt>
                <c:pt idx="2">
                  <c:v>45.039419676749283</c:v>
                </c:pt>
                <c:pt idx="3">
                  <c:v>80.629888083274579</c:v>
                </c:pt>
                <c:pt idx="4">
                  <c:v>80.59883529241587</c:v>
                </c:pt>
                <c:pt idx="5">
                  <c:v>74.9208574068704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38-46AA-87ED-CE4DBC033191}"/>
            </c:ext>
          </c:extLst>
        </c:ser>
        <c:ser>
          <c:idx val="1"/>
          <c:order val="1"/>
          <c:tx>
            <c:strRef>
              <c:f>'follow up wo outliers'!$P$113</c:f>
              <c:strCache>
                <c:ptCount val="1"/>
                <c:pt idx="0">
                  <c:v>PC3 PGC1A Clover Ctrl Dox</c:v>
                </c:pt>
              </c:strCache>
            </c:strRef>
          </c:tx>
          <c:spPr>
            <a:ln w="9525"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plus"/>
            <c:errValType val="stdErr"/>
            <c:noEndCap val="0"/>
          </c:errBars>
          <c:cat>
            <c:numRef>
              <c:f>'follow up wo outliers'!$Q$111:$V$111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3</c:v>
                </c:pt>
                <c:pt idx="5">
                  <c:v>16</c:v>
                </c:pt>
              </c:numCache>
            </c:numRef>
          </c:cat>
          <c:val>
            <c:numRef>
              <c:f>'follow up wo outliers'!$Q$113:$V$113</c:f>
              <c:numCache>
                <c:formatCode>0.00E+00</c:formatCode>
                <c:ptCount val="6"/>
                <c:pt idx="0">
                  <c:v>1</c:v>
                </c:pt>
                <c:pt idx="1">
                  <c:v>4.0506863947402882</c:v>
                </c:pt>
                <c:pt idx="2">
                  <c:v>11.400907692119988</c:v>
                </c:pt>
                <c:pt idx="3">
                  <c:v>74.185241178700593</c:v>
                </c:pt>
                <c:pt idx="4">
                  <c:v>112.24420671021771</c:v>
                </c:pt>
                <c:pt idx="5">
                  <c:v>201.801647657471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D38-46AA-87ED-CE4DBC0331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6625760"/>
        <c:axId val="1"/>
      </c:lineChart>
      <c:catAx>
        <c:axId val="386625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0.0E+00" sourceLinked="0"/>
        <c:majorTickMark val="out"/>
        <c:minorTickMark val="out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386625760"/>
        <c:crosses val="autoZero"/>
        <c:crossBetween val="between"/>
      </c:valAx>
      <c:spPr>
        <a:noFill/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58461239351917"/>
          <c:y val="0.11768961564778536"/>
          <c:w val="0.6577222679437088"/>
          <c:h val="0.77157397733031097"/>
        </c:manualLayout>
      </c:layout>
      <c:lineChart>
        <c:grouping val="standard"/>
        <c:varyColors val="0"/>
        <c:ser>
          <c:idx val="0"/>
          <c:order val="0"/>
          <c:tx>
            <c:strRef>
              <c:f>'follow up wo outliers'!$P$116</c:f>
              <c:strCache>
                <c:ptCount val="1"/>
                <c:pt idx="0">
                  <c:v>PC3 PGC1A SRM No Dox</c:v>
                </c:pt>
              </c:strCache>
            </c:strRef>
          </c:tx>
          <c:spPr>
            <a:ln w="952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follow up wo outliers'!$Q$115:$V$11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3</c:v>
                </c:pt>
                <c:pt idx="5">
                  <c:v>16</c:v>
                </c:pt>
              </c:numCache>
            </c:numRef>
          </c:cat>
          <c:val>
            <c:numRef>
              <c:f>'follow up wo outliers'!$Q$116:$V$116</c:f>
              <c:numCache>
                <c:formatCode>0.00E+00</c:formatCode>
                <c:ptCount val="6"/>
                <c:pt idx="0">
                  <c:v>1</c:v>
                </c:pt>
                <c:pt idx="1">
                  <c:v>5.5292378405438658</c:v>
                </c:pt>
                <c:pt idx="2">
                  <c:v>17.690150538373441</c:v>
                </c:pt>
                <c:pt idx="3">
                  <c:v>41.744265626574062</c:v>
                </c:pt>
                <c:pt idx="4">
                  <c:v>80.093584909738425</c:v>
                </c:pt>
                <c:pt idx="5">
                  <c:v>77.8944426691122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265-45FD-BB16-B707660F6902}"/>
            </c:ext>
          </c:extLst>
        </c:ser>
        <c:ser>
          <c:idx val="1"/>
          <c:order val="1"/>
          <c:tx>
            <c:strRef>
              <c:f>'follow up wo outliers'!$P$117</c:f>
              <c:strCache>
                <c:ptCount val="1"/>
                <c:pt idx="0">
                  <c:v>PC3 PGC1A SRM Dox</c:v>
                </c:pt>
              </c:strCache>
            </c:strRef>
          </c:tx>
          <c:spPr>
            <a:ln w="952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follow up wo outliers'!$Q$115:$V$11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3</c:v>
                </c:pt>
                <c:pt idx="5">
                  <c:v>16</c:v>
                </c:pt>
              </c:numCache>
            </c:numRef>
          </c:cat>
          <c:val>
            <c:numRef>
              <c:f>'follow up wo outliers'!$Q$117:$V$117</c:f>
              <c:numCache>
                <c:formatCode>0.00E+00</c:formatCode>
                <c:ptCount val="6"/>
                <c:pt idx="0">
                  <c:v>1</c:v>
                </c:pt>
                <c:pt idx="1">
                  <c:v>2.1675873967663737</c:v>
                </c:pt>
                <c:pt idx="2">
                  <c:v>9.6930776205165294</c:v>
                </c:pt>
                <c:pt idx="3">
                  <c:v>55.048026365638762</c:v>
                </c:pt>
                <c:pt idx="4">
                  <c:v>51.881851282287229</c:v>
                </c:pt>
                <c:pt idx="5">
                  <c:v>89.79850044102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265-45FD-BB16-B707660F69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12025112"/>
        <c:axId val="512032984"/>
      </c:lineChart>
      <c:catAx>
        <c:axId val="512025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12032984"/>
        <c:crosses val="autoZero"/>
        <c:auto val="1"/>
        <c:lblAlgn val="ctr"/>
        <c:lblOffset val="100"/>
        <c:noMultiLvlLbl val="0"/>
      </c:catAx>
      <c:valAx>
        <c:axId val="512032984"/>
        <c:scaling>
          <c:orientation val="minMax"/>
        </c:scaling>
        <c:delete val="0"/>
        <c:axPos val="l"/>
        <c:numFmt formatCode="0.0E+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12025112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31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456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125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760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4276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2202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951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406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815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572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641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705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oleObject" Target="../embeddings/oleObject5.bin"/><Relationship Id="rId3" Type="http://schemas.openxmlformats.org/officeDocument/2006/relationships/image" Target="../media/image6.pn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6" Type="http://schemas.openxmlformats.org/officeDocument/2006/relationships/chart" Target="../charts/char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5" Type="http://schemas.openxmlformats.org/officeDocument/2006/relationships/chart" Target="../charts/chart1.xml"/><Relationship Id="rId10" Type="http://schemas.openxmlformats.org/officeDocument/2006/relationships/image" Target="../media/image3.emf"/><Relationship Id="rId4" Type="http://schemas.openxmlformats.org/officeDocument/2006/relationships/image" Target="../media/image7.pn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1902817" y="5129655"/>
            <a:ext cx="496029" cy="409007"/>
          </a:xfrm>
          <a:prstGeom prst="rect">
            <a:avLst/>
          </a:prstGeom>
        </p:spPr>
      </p:pic>
      <p:pic>
        <p:nvPicPr>
          <p:cNvPr id="8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1877083" y="4653371"/>
            <a:ext cx="496029" cy="409007"/>
          </a:xfrm>
          <a:prstGeom prst="rect">
            <a:avLst/>
          </a:prstGeom>
        </p:spPr>
      </p:pic>
      <p:pic>
        <p:nvPicPr>
          <p:cNvPr id="77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1879274" y="3938286"/>
            <a:ext cx="496029" cy="409007"/>
          </a:xfrm>
          <a:prstGeom prst="rect">
            <a:avLst/>
          </a:prstGeom>
        </p:spPr>
      </p:pic>
      <p:pic>
        <p:nvPicPr>
          <p:cNvPr id="64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22" t="53214" r="35536" b="41590"/>
          <a:stretch/>
        </p:blipFill>
        <p:spPr bwMode="auto">
          <a:xfrm>
            <a:off x="1293446" y="4646232"/>
            <a:ext cx="390605" cy="369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Rectángulo redondeado 66"/>
          <p:cNvSpPr/>
          <p:nvPr/>
        </p:nvSpPr>
        <p:spPr>
          <a:xfrm>
            <a:off x="1770894" y="3240374"/>
            <a:ext cx="759877" cy="11669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ipient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ángulo redondeado 67"/>
          <p:cNvSpPr/>
          <p:nvPr/>
        </p:nvSpPr>
        <p:spPr>
          <a:xfrm>
            <a:off x="1103380" y="4243406"/>
            <a:ext cx="662325" cy="222012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</a:p>
        </p:txBody>
      </p:sp>
      <p:pic>
        <p:nvPicPr>
          <p:cNvPr id="69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44423" r="47420" b="49629"/>
          <a:stretch/>
        </p:blipFill>
        <p:spPr>
          <a:xfrm>
            <a:off x="1320712" y="3535506"/>
            <a:ext cx="300038" cy="285402"/>
          </a:xfrm>
          <a:prstGeom prst="rect">
            <a:avLst/>
          </a:prstGeom>
        </p:spPr>
      </p:pic>
      <p:pic>
        <p:nvPicPr>
          <p:cNvPr id="70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4" t="44302" r="56007" b="51142"/>
          <a:stretch/>
        </p:blipFill>
        <p:spPr>
          <a:xfrm>
            <a:off x="729146" y="3503356"/>
            <a:ext cx="685473" cy="288688"/>
          </a:xfrm>
          <a:prstGeom prst="rect">
            <a:avLst/>
          </a:prstGeom>
        </p:spPr>
      </p:pic>
      <p:pic>
        <p:nvPicPr>
          <p:cNvPr id="72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52157" r="47420" b="41185"/>
          <a:stretch/>
        </p:blipFill>
        <p:spPr>
          <a:xfrm>
            <a:off x="1285132" y="3946800"/>
            <a:ext cx="300038" cy="319435"/>
          </a:xfrm>
          <a:prstGeom prst="rect">
            <a:avLst/>
          </a:prstGeom>
        </p:spPr>
      </p:pic>
      <p:sp>
        <p:nvSpPr>
          <p:cNvPr id="73" name="Rectángulo redondeado 72"/>
          <p:cNvSpPr/>
          <p:nvPr/>
        </p:nvSpPr>
        <p:spPr>
          <a:xfrm>
            <a:off x="1137601" y="3766822"/>
            <a:ext cx="662325" cy="20015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</a:p>
        </p:txBody>
      </p:sp>
      <p:sp>
        <p:nvSpPr>
          <p:cNvPr id="74" name="Rectángulo redondeado 73"/>
          <p:cNvSpPr/>
          <p:nvPr/>
        </p:nvSpPr>
        <p:spPr>
          <a:xfrm>
            <a:off x="133571" y="3521746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1917722" y="3495170"/>
            <a:ext cx="496029" cy="409007"/>
          </a:xfrm>
          <a:prstGeom prst="rect">
            <a:avLst/>
          </a:prstGeom>
        </p:spPr>
      </p:pic>
      <p:sp>
        <p:nvSpPr>
          <p:cNvPr id="80" name="Rectángulo redondeado 79"/>
          <p:cNvSpPr/>
          <p:nvPr/>
        </p:nvSpPr>
        <p:spPr>
          <a:xfrm>
            <a:off x="329441" y="3411325"/>
            <a:ext cx="2069406" cy="1037166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82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25" t="53214" r="41406" b="41590"/>
          <a:stretch/>
        </p:blipFill>
        <p:spPr bwMode="auto">
          <a:xfrm>
            <a:off x="803800" y="4679807"/>
            <a:ext cx="541286" cy="309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3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83" t="41463" r="40708" b="53341"/>
          <a:stretch/>
        </p:blipFill>
        <p:spPr bwMode="auto">
          <a:xfrm>
            <a:off x="796868" y="4006698"/>
            <a:ext cx="496629" cy="2578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7" name="Rectángulo redondeado 86"/>
          <p:cNvSpPr/>
          <p:nvPr/>
        </p:nvSpPr>
        <p:spPr>
          <a:xfrm>
            <a:off x="1045380" y="4898680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 &amp; SRM)</a:t>
            </a:r>
          </a:p>
        </p:txBody>
      </p:sp>
      <p:sp>
        <p:nvSpPr>
          <p:cNvPr id="88" name="Rectángulo redondeado 87"/>
          <p:cNvSpPr/>
          <p:nvPr/>
        </p:nvSpPr>
        <p:spPr>
          <a:xfrm>
            <a:off x="133571" y="3967582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ángulo redondeado 88"/>
          <p:cNvSpPr/>
          <p:nvPr/>
        </p:nvSpPr>
        <p:spPr>
          <a:xfrm>
            <a:off x="121706" y="4649104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ángulo redondeado 89"/>
          <p:cNvSpPr/>
          <p:nvPr/>
        </p:nvSpPr>
        <p:spPr>
          <a:xfrm>
            <a:off x="103721" y="5168875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41" t="48745" r="41290" b="46059"/>
          <a:stretch/>
        </p:blipFill>
        <p:spPr bwMode="auto">
          <a:xfrm>
            <a:off x="780074" y="5190808"/>
            <a:ext cx="537806" cy="3072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60" t="48844" r="35598" b="47030"/>
          <a:stretch/>
        </p:blipFill>
        <p:spPr bwMode="auto">
          <a:xfrm>
            <a:off x="1254462" y="5173279"/>
            <a:ext cx="390605" cy="293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3" name="Rectángulo redondeado 92"/>
          <p:cNvSpPr/>
          <p:nvPr/>
        </p:nvSpPr>
        <p:spPr>
          <a:xfrm>
            <a:off x="905070" y="5401349"/>
            <a:ext cx="950055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 &amp; SRM)</a:t>
            </a:r>
          </a:p>
        </p:txBody>
      </p:sp>
      <p:sp>
        <p:nvSpPr>
          <p:cNvPr id="96" name="Rectángulo redondeado 95"/>
          <p:cNvSpPr/>
          <p:nvPr/>
        </p:nvSpPr>
        <p:spPr>
          <a:xfrm>
            <a:off x="329439" y="4513495"/>
            <a:ext cx="2060175" cy="1124875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Flecha derecha 8"/>
          <p:cNvSpPr/>
          <p:nvPr/>
        </p:nvSpPr>
        <p:spPr>
          <a:xfrm>
            <a:off x="1647660" y="3625904"/>
            <a:ext cx="288000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6" name="Flecha derecha 105"/>
          <p:cNvSpPr/>
          <p:nvPr/>
        </p:nvSpPr>
        <p:spPr>
          <a:xfrm>
            <a:off x="1625602" y="4079332"/>
            <a:ext cx="288000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7" name="Flecha derecha 106"/>
          <p:cNvSpPr/>
          <p:nvPr/>
        </p:nvSpPr>
        <p:spPr>
          <a:xfrm>
            <a:off x="1631054" y="4772120"/>
            <a:ext cx="288000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8" name="Flecha derecha 107"/>
          <p:cNvSpPr/>
          <p:nvPr/>
        </p:nvSpPr>
        <p:spPr>
          <a:xfrm>
            <a:off x="1639291" y="5270253"/>
            <a:ext cx="288000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Rectángulo redondeado 83"/>
          <p:cNvSpPr/>
          <p:nvPr/>
        </p:nvSpPr>
        <p:spPr>
          <a:xfrm>
            <a:off x="1178741" y="3263201"/>
            <a:ext cx="1210873" cy="11669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ángulo redondeado 85"/>
          <p:cNvSpPr/>
          <p:nvPr/>
        </p:nvSpPr>
        <p:spPr>
          <a:xfrm>
            <a:off x="329441" y="3253367"/>
            <a:ext cx="1210873" cy="11669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r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5213" r="41030" b="29930"/>
          <a:stretch/>
        </p:blipFill>
        <p:spPr bwMode="auto">
          <a:xfrm>
            <a:off x="4524517" y="7344112"/>
            <a:ext cx="649760" cy="3387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36" name="Objeto 135"/>
          <p:cNvGraphicFramePr>
            <a:graphicFrameLocks noChangeAspect="1"/>
          </p:cNvGraphicFramePr>
          <p:nvPr>
            <p:extLst/>
          </p:nvPr>
        </p:nvGraphicFramePr>
        <p:xfrm>
          <a:off x="172672" y="1069031"/>
          <a:ext cx="1889125" cy="192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10" r:id="rId5" imgW="1888912" imgH="1920491" progId="Prism10.Document">
                  <p:embed/>
                </p:oleObj>
              </mc:Choice>
              <mc:Fallback>
                <p:oleObj name="Prism 10" r:id="rId5" imgW="1888912" imgH="1920491" progId="Prism10.Document">
                  <p:embed/>
                  <p:pic>
                    <p:nvPicPr>
                      <p:cNvPr id="136" name="Objeto 13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2672" y="1069031"/>
                        <a:ext cx="1889125" cy="192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9" name="CuadroTexto 138"/>
          <p:cNvSpPr txBox="1"/>
          <p:nvPr/>
        </p:nvSpPr>
        <p:spPr>
          <a:xfrm>
            <a:off x="804308" y="1093853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Conector recto 139"/>
          <p:cNvCxnSpPr/>
          <p:nvPr/>
        </p:nvCxnSpPr>
        <p:spPr>
          <a:xfrm>
            <a:off x="887639" y="1250292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CuadroTexto 140"/>
          <p:cNvSpPr txBox="1"/>
          <p:nvPr/>
        </p:nvSpPr>
        <p:spPr>
          <a:xfrm>
            <a:off x="1304050" y="1611751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Conector recto 141"/>
          <p:cNvCxnSpPr/>
          <p:nvPr/>
        </p:nvCxnSpPr>
        <p:spPr>
          <a:xfrm>
            <a:off x="1387381" y="176819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78">
            <a:extLst>
              <a:ext uri="{FF2B5EF4-FFF2-40B4-BE49-F238E27FC236}">
                <a16:creationId xmlns:a16="http://schemas.microsoft.com/office/drawing/2014/main" id="{CEB061AB-415B-4FF6-7642-2183DD5CE48D}"/>
              </a:ext>
            </a:extLst>
          </p:cNvPr>
          <p:cNvSpPr txBox="1"/>
          <p:nvPr/>
        </p:nvSpPr>
        <p:spPr>
          <a:xfrm>
            <a:off x="136957" y="670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79" name="Objeto 78"/>
          <p:cNvGraphicFramePr>
            <a:graphicFrameLocks noChangeAspect="1"/>
          </p:cNvGraphicFramePr>
          <p:nvPr>
            <p:extLst/>
          </p:nvPr>
        </p:nvGraphicFramePr>
        <p:xfrm>
          <a:off x="336219" y="6510033"/>
          <a:ext cx="1628775" cy="1830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10" r:id="rId7" imgW="1628174" imgH="1831023" progId="Prism10.Document">
                  <p:embed/>
                </p:oleObj>
              </mc:Choice>
              <mc:Fallback>
                <p:oleObj name="Prism 10" r:id="rId7" imgW="1628174" imgH="1831023" progId="Prism10.Document">
                  <p:embed/>
                  <p:pic>
                    <p:nvPicPr>
                      <p:cNvPr id="79" name="Objeto 7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6219" y="6510033"/>
                        <a:ext cx="1628775" cy="1830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78">
            <a:extLst>
              <a:ext uri="{FF2B5EF4-FFF2-40B4-BE49-F238E27FC236}">
                <a16:creationId xmlns:a16="http://schemas.microsoft.com/office/drawing/2014/main" id="{746D00B2-182A-F5C4-70D7-45C27C052198}"/>
              </a:ext>
            </a:extLst>
          </p:cNvPr>
          <p:cNvSpPr txBox="1"/>
          <p:nvPr/>
        </p:nvSpPr>
        <p:spPr>
          <a:xfrm>
            <a:off x="4120729" y="670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4" name="Objeto 13">
            <a:extLst>
              <a:ext uri="{FF2B5EF4-FFF2-40B4-BE49-F238E27FC236}">
                <a16:creationId xmlns:a16="http://schemas.microsoft.com/office/drawing/2014/main" id="{3F4B8E62-C062-BF2F-3495-D4E274FD481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996362" y="6271621"/>
          <a:ext cx="1911350" cy="1970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10" r:id="rId9" imgW="1911961" imgH="1969682" progId="Prism10.Document">
                  <p:embed/>
                </p:oleObj>
              </mc:Choice>
              <mc:Fallback>
                <p:oleObj name="Prism 10" r:id="rId9" imgW="1911961" imgH="1969682" progId="Prism10.Document">
                  <p:embed/>
                  <p:pic>
                    <p:nvPicPr>
                      <p:cNvPr id="14" name="Objeto 13">
                        <a:extLst>
                          <a:ext uri="{FF2B5EF4-FFF2-40B4-BE49-F238E27FC236}">
                            <a16:creationId xmlns:a16="http://schemas.microsoft.com/office/drawing/2014/main" id="{3F4B8E62-C062-BF2F-3495-D4E274FD48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996362" y="6271621"/>
                        <a:ext cx="1911350" cy="1970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78">
            <a:extLst>
              <a:ext uri="{FF2B5EF4-FFF2-40B4-BE49-F238E27FC236}">
                <a16:creationId xmlns:a16="http://schemas.microsoft.com/office/drawing/2014/main" id="{B0FE3A75-FD77-FC5A-0880-4ADD1F7004DD}"/>
              </a:ext>
            </a:extLst>
          </p:cNvPr>
          <p:cNvSpPr txBox="1"/>
          <p:nvPr/>
        </p:nvSpPr>
        <p:spPr>
          <a:xfrm>
            <a:off x="172672" y="298974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TextBox 78">
            <a:extLst>
              <a:ext uri="{FF2B5EF4-FFF2-40B4-BE49-F238E27FC236}">
                <a16:creationId xmlns:a16="http://schemas.microsoft.com/office/drawing/2014/main" id="{620CB4B3-7C73-7255-A1F7-2A05DF2D12DF}"/>
              </a:ext>
            </a:extLst>
          </p:cNvPr>
          <p:cNvSpPr txBox="1"/>
          <p:nvPr/>
        </p:nvSpPr>
        <p:spPr>
          <a:xfrm>
            <a:off x="1907904" y="670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98" name="Conector recto 97"/>
          <p:cNvCxnSpPr>
            <a:cxnSpLocks/>
          </p:cNvCxnSpPr>
          <p:nvPr/>
        </p:nvCxnSpPr>
        <p:spPr>
          <a:xfrm>
            <a:off x="1748120" y="3209950"/>
            <a:ext cx="0" cy="252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ector recto 98"/>
          <p:cNvCxnSpPr>
            <a:cxnSpLocks/>
          </p:cNvCxnSpPr>
          <p:nvPr/>
        </p:nvCxnSpPr>
        <p:spPr>
          <a:xfrm>
            <a:off x="2376902" y="3209950"/>
            <a:ext cx="0" cy="252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19" t="60113" r="34984" b="36315"/>
          <a:stretch/>
        </p:blipFill>
        <p:spPr bwMode="auto">
          <a:xfrm>
            <a:off x="5184106" y="7932280"/>
            <a:ext cx="459864" cy="274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1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15" t="64900" r="34984" b="29930"/>
          <a:stretch/>
        </p:blipFill>
        <p:spPr bwMode="auto">
          <a:xfrm>
            <a:off x="5150769" y="7300795"/>
            <a:ext cx="493201" cy="396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ángulo redondeado 14"/>
          <p:cNvSpPr/>
          <p:nvPr/>
        </p:nvSpPr>
        <p:spPr>
          <a:xfrm>
            <a:off x="5147794" y="6249851"/>
            <a:ext cx="701815" cy="269531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dia</a:t>
            </a:r>
          </a:p>
        </p:txBody>
      </p:sp>
      <p:sp>
        <p:nvSpPr>
          <p:cNvPr id="16" name="Rectángulo redondeado 15"/>
          <p:cNvSpPr/>
          <p:nvPr/>
        </p:nvSpPr>
        <p:spPr>
          <a:xfrm>
            <a:off x="4155120" y="6249851"/>
            <a:ext cx="1070712" cy="164949"/>
          </a:xfrm>
          <a:prstGeom prst="round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r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8" name="Rectángulo redondeado 17"/>
          <p:cNvSpPr/>
          <p:nvPr/>
        </p:nvSpPr>
        <p:spPr>
          <a:xfrm>
            <a:off x="5827391" y="6249851"/>
            <a:ext cx="781678" cy="134254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ipient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ángulo redondeado 18"/>
          <p:cNvSpPr/>
          <p:nvPr/>
        </p:nvSpPr>
        <p:spPr>
          <a:xfrm>
            <a:off x="5082875" y="7687081"/>
            <a:ext cx="662325" cy="87312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shSRM#1)</a:t>
            </a:r>
          </a:p>
        </p:txBody>
      </p:sp>
      <p:pic>
        <p:nvPicPr>
          <p:cNvPr id="20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44423" r="47420" b="49629"/>
          <a:stretch/>
        </p:blipFill>
        <p:spPr>
          <a:xfrm>
            <a:off x="5242378" y="6633046"/>
            <a:ext cx="300038" cy="285402"/>
          </a:xfrm>
          <a:prstGeom prst="rect">
            <a:avLst/>
          </a:prstGeom>
        </p:spPr>
      </p:pic>
      <p:pic>
        <p:nvPicPr>
          <p:cNvPr id="2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4" t="44302" r="56007" b="51142"/>
          <a:stretch/>
        </p:blipFill>
        <p:spPr>
          <a:xfrm>
            <a:off x="4400250" y="6550866"/>
            <a:ext cx="769471" cy="324064"/>
          </a:xfrm>
          <a:prstGeom prst="rect">
            <a:avLst/>
          </a:prstGeom>
        </p:spPr>
      </p:pic>
      <p:pic>
        <p:nvPicPr>
          <p:cNvPr id="22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03686" y="6546500"/>
            <a:ext cx="584375" cy="481854"/>
          </a:xfrm>
          <a:prstGeom prst="rect">
            <a:avLst/>
          </a:prstGeom>
        </p:spPr>
      </p:pic>
      <p:sp>
        <p:nvSpPr>
          <p:cNvPr id="25" name="Rectángulo redondeado 24"/>
          <p:cNvSpPr/>
          <p:nvPr/>
        </p:nvSpPr>
        <p:spPr>
          <a:xfrm>
            <a:off x="5065364" y="6965400"/>
            <a:ext cx="662325" cy="8731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6" name="Rectángulo redondeado 25"/>
          <p:cNvSpPr/>
          <p:nvPr/>
        </p:nvSpPr>
        <p:spPr>
          <a:xfrm>
            <a:off x="3849267" y="6726257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03686" y="7265868"/>
            <a:ext cx="584375" cy="481854"/>
          </a:xfrm>
          <a:prstGeom prst="rect">
            <a:avLst/>
          </a:prstGeom>
        </p:spPr>
      </p:pic>
      <p:sp>
        <p:nvSpPr>
          <p:cNvPr id="31" name="Rectángulo redondeado 30"/>
          <p:cNvSpPr/>
          <p:nvPr/>
        </p:nvSpPr>
        <p:spPr>
          <a:xfrm>
            <a:off x="4169524" y="6505386"/>
            <a:ext cx="2407818" cy="634543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Rectángulo redondeado 31"/>
          <p:cNvSpPr/>
          <p:nvPr/>
        </p:nvSpPr>
        <p:spPr>
          <a:xfrm>
            <a:off x="4169523" y="7188791"/>
            <a:ext cx="2407819" cy="1268098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38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8241" b="50022"/>
          <a:stretch/>
        </p:blipFill>
        <p:spPr>
          <a:xfrm>
            <a:off x="5992968" y="7858567"/>
            <a:ext cx="511040" cy="481854"/>
          </a:xfrm>
          <a:prstGeom prst="rect">
            <a:avLst/>
          </a:prstGeom>
        </p:spPr>
      </p:pic>
      <p:sp>
        <p:nvSpPr>
          <p:cNvPr id="40" name="Rectángulo redondeado 39"/>
          <p:cNvSpPr/>
          <p:nvPr/>
        </p:nvSpPr>
        <p:spPr>
          <a:xfrm>
            <a:off x="5073638" y="8193437"/>
            <a:ext cx="662325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shSRM#2)</a:t>
            </a:r>
          </a:p>
        </p:txBody>
      </p:sp>
      <p:cxnSp>
        <p:nvCxnSpPr>
          <p:cNvPr id="5" name="Conector recto 4"/>
          <p:cNvCxnSpPr/>
          <p:nvPr/>
        </p:nvCxnSpPr>
        <p:spPr>
          <a:xfrm>
            <a:off x="5146861" y="6248306"/>
            <a:ext cx="0" cy="2232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ector recto 96"/>
          <p:cNvCxnSpPr/>
          <p:nvPr/>
        </p:nvCxnSpPr>
        <p:spPr>
          <a:xfrm>
            <a:off x="5814566" y="6248306"/>
            <a:ext cx="0" cy="2232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0113" r="41160" b="36129"/>
          <a:stretch/>
        </p:blipFill>
        <p:spPr bwMode="auto">
          <a:xfrm>
            <a:off x="4536639" y="7941916"/>
            <a:ext cx="645331" cy="265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9" name="Flecha derecha 108"/>
          <p:cNvSpPr/>
          <p:nvPr/>
        </p:nvSpPr>
        <p:spPr>
          <a:xfrm>
            <a:off x="5603230" y="6716297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0" name="Flecha derecha 109"/>
          <p:cNvSpPr/>
          <p:nvPr/>
        </p:nvSpPr>
        <p:spPr>
          <a:xfrm>
            <a:off x="5588727" y="7443243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1" name="Flecha derecha 110"/>
          <p:cNvSpPr/>
          <p:nvPr/>
        </p:nvSpPr>
        <p:spPr>
          <a:xfrm>
            <a:off x="5588727" y="7993877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4" name="CuadroTexto 113"/>
          <p:cNvSpPr txBox="1"/>
          <p:nvPr/>
        </p:nvSpPr>
        <p:spPr>
          <a:xfrm>
            <a:off x="817327" y="6303235"/>
            <a:ext cx="9412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PC3 producer cells</a:t>
            </a:r>
          </a:p>
        </p:txBody>
      </p:sp>
      <p:sp>
        <p:nvSpPr>
          <p:cNvPr id="115" name="CuadroTexto 114"/>
          <p:cNvSpPr txBox="1"/>
          <p:nvPr/>
        </p:nvSpPr>
        <p:spPr>
          <a:xfrm>
            <a:off x="2511191" y="6303235"/>
            <a:ext cx="9412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PC3 producer cells</a:t>
            </a:r>
          </a:p>
        </p:txBody>
      </p:sp>
      <p:sp>
        <p:nvSpPr>
          <p:cNvPr id="116" name="TextBox 78">
            <a:extLst>
              <a:ext uri="{FF2B5EF4-FFF2-40B4-BE49-F238E27FC236}">
                <a16:creationId xmlns:a16="http://schemas.microsoft.com/office/drawing/2014/main" id="{B0FE3A75-FD77-FC5A-0880-4ADD1F7004DD}"/>
              </a:ext>
            </a:extLst>
          </p:cNvPr>
          <p:cNvSpPr txBox="1"/>
          <p:nvPr/>
        </p:nvSpPr>
        <p:spPr>
          <a:xfrm>
            <a:off x="2547926" y="320995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7" name="Rectángulo redondeado 36"/>
          <p:cNvSpPr/>
          <p:nvPr/>
        </p:nvSpPr>
        <p:spPr>
          <a:xfrm>
            <a:off x="3927458" y="7788031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RM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27" name="Rectángulo redondeado 26"/>
          <p:cNvSpPr/>
          <p:nvPr/>
        </p:nvSpPr>
        <p:spPr>
          <a:xfrm>
            <a:off x="3918575" y="7252259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RM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graphicFrame>
        <p:nvGraphicFramePr>
          <p:cNvPr id="75" name="Objeto 74"/>
          <p:cNvGraphicFramePr>
            <a:graphicFrameLocks noChangeAspect="1"/>
          </p:cNvGraphicFramePr>
          <p:nvPr>
            <p:extLst/>
          </p:nvPr>
        </p:nvGraphicFramePr>
        <p:xfrm>
          <a:off x="4435239" y="708409"/>
          <a:ext cx="1565275" cy="2435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10" r:id="rId11" imgW="1565870" imgH="2435001" progId="Prism10.Document">
                  <p:embed/>
                </p:oleObj>
              </mc:Choice>
              <mc:Fallback>
                <p:oleObj name="Prism 10" r:id="rId11" imgW="1565870" imgH="2435001" progId="Prism10.Document">
                  <p:embed/>
                  <p:pic>
                    <p:nvPicPr>
                      <p:cNvPr id="75" name="Objeto 7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35239" y="708409"/>
                        <a:ext cx="1565275" cy="2435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5" name="TextBox 78">
            <a:extLst>
              <a:ext uri="{FF2B5EF4-FFF2-40B4-BE49-F238E27FC236}">
                <a16:creationId xmlns:a16="http://schemas.microsoft.com/office/drawing/2014/main" id="{B0FE3A75-FD77-FC5A-0880-4ADD1F7004DD}"/>
              </a:ext>
            </a:extLst>
          </p:cNvPr>
          <p:cNvSpPr txBox="1"/>
          <p:nvPr/>
        </p:nvSpPr>
        <p:spPr>
          <a:xfrm>
            <a:off x="304632" y="610220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894F4BF4-EC0A-A4DE-D42E-17F7356FCC5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021355" y="1001563"/>
          <a:ext cx="1716088" cy="1938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10" r:id="rId13" imgW="1715326" imgH="1937989" progId="Prism10.Document">
                  <p:embed/>
                </p:oleObj>
              </mc:Choice>
              <mc:Fallback>
                <p:oleObj name="Prism 10" r:id="rId13" imgW="1715326" imgH="1937989" progId="Prism10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894F4BF4-EC0A-A4DE-D42E-17F7356FCC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021355" y="1001563"/>
                        <a:ext cx="1716088" cy="1938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8">
            <a:extLst>
              <a:ext uri="{FF2B5EF4-FFF2-40B4-BE49-F238E27FC236}">
                <a16:creationId xmlns:a16="http://schemas.microsoft.com/office/drawing/2014/main" id="{0B2A41E8-B273-F5F7-B2A7-1AA26510674B}"/>
              </a:ext>
            </a:extLst>
          </p:cNvPr>
          <p:cNvSpPr txBox="1"/>
          <p:nvPr/>
        </p:nvSpPr>
        <p:spPr>
          <a:xfrm>
            <a:off x="1929206" y="6134565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85" name="CuadroTexto 84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 rot="16200000">
            <a:off x="2201540" y="4379295"/>
            <a:ext cx="116337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total flux</a:t>
            </a:r>
          </a:p>
        </p:txBody>
      </p:sp>
      <p:sp>
        <p:nvSpPr>
          <p:cNvPr id="94" name="CuadroTexto 93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2990826" y="3443020"/>
            <a:ext cx="17483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PC3-luc + PC3 TRIPZ-PGC1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No </a:t>
            </a:r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Conector recto 103"/>
          <p:cNvCxnSpPr/>
          <p:nvPr/>
        </p:nvCxnSpPr>
        <p:spPr>
          <a:xfrm>
            <a:off x="3077120" y="3525397"/>
            <a:ext cx="1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Conector recto 104"/>
          <p:cNvCxnSpPr/>
          <p:nvPr/>
        </p:nvCxnSpPr>
        <p:spPr>
          <a:xfrm>
            <a:off x="3083470" y="3677797"/>
            <a:ext cx="108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CuadroTexto 111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2965047" y="3584113"/>
            <a:ext cx="17483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PC3-luc + PC3 TRIPZ-PGC1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CuadroTexto 112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5028044" y="3443020"/>
            <a:ext cx="17483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PC3-luc + PC3 TRIPZ-PGC1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/SRM No </a:t>
            </a:r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Conector recto 116"/>
          <p:cNvCxnSpPr/>
          <p:nvPr/>
        </p:nvCxnSpPr>
        <p:spPr>
          <a:xfrm>
            <a:off x="5012738" y="3531747"/>
            <a:ext cx="10800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Conector recto 117"/>
          <p:cNvCxnSpPr/>
          <p:nvPr/>
        </p:nvCxnSpPr>
        <p:spPr>
          <a:xfrm>
            <a:off x="5019088" y="3684147"/>
            <a:ext cx="108000" cy="0"/>
          </a:xfrm>
          <a:prstGeom prst="line">
            <a:avLst/>
          </a:prstGeom>
          <a:ln w="127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CuadroTexto 118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5002265" y="3584113"/>
            <a:ext cx="17483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PC3-luc + PC3 TRIPZ-PGC1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/SRM + </a:t>
            </a:r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0" name="Gráfico 119"/>
          <p:cNvGraphicFramePr>
            <a:graphicFrameLocks/>
          </p:cNvGraphicFramePr>
          <p:nvPr>
            <p:extLst/>
          </p:nvPr>
        </p:nvGraphicFramePr>
        <p:xfrm>
          <a:off x="2807000" y="3731364"/>
          <a:ext cx="2027091" cy="1613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21" name="Gráfico 120"/>
          <p:cNvGraphicFramePr>
            <a:graphicFrameLocks/>
          </p:cNvGraphicFramePr>
          <p:nvPr>
            <p:extLst/>
          </p:nvPr>
        </p:nvGraphicFramePr>
        <p:xfrm>
          <a:off x="4730168" y="3682045"/>
          <a:ext cx="2194446" cy="1606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122" name="Rectángulo 121"/>
          <p:cNvSpPr/>
          <p:nvPr/>
        </p:nvSpPr>
        <p:spPr>
          <a:xfrm>
            <a:off x="3743707" y="4646120"/>
            <a:ext cx="204977" cy="649694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4" name="Rectángulo 123"/>
          <p:cNvSpPr/>
          <p:nvPr/>
        </p:nvSpPr>
        <p:spPr>
          <a:xfrm>
            <a:off x="4239491" y="3897634"/>
            <a:ext cx="428777" cy="1398180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5" name="Rectángulo 124"/>
          <p:cNvSpPr/>
          <p:nvPr/>
        </p:nvSpPr>
        <p:spPr>
          <a:xfrm>
            <a:off x="5620974" y="4646120"/>
            <a:ext cx="204977" cy="649694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7" name="Rectángulo 126"/>
          <p:cNvSpPr/>
          <p:nvPr/>
        </p:nvSpPr>
        <p:spPr>
          <a:xfrm>
            <a:off x="6077926" y="3923938"/>
            <a:ext cx="467609" cy="1371876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8" name="TextBox 78">
            <a:extLst>
              <a:ext uri="{FF2B5EF4-FFF2-40B4-BE49-F238E27FC236}">
                <a16:creationId xmlns:a16="http://schemas.microsoft.com/office/drawing/2014/main" id="{0B2A41E8-B273-F5F7-B2A7-1AA26510674B}"/>
              </a:ext>
            </a:extLst>
          </p:cNvPr>
          <p:cNvSpPr txBox="1"/>
          <p:nvPr/>
        </p:nvSpPr>
        <p:spPr>
          <a:xfrm>
            <a:off x="3831347" y="610220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29" name="CuadroTexto 128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3475931" y="5324762"/>
            <a:ext cx="10062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0" name="CuadroTexto 129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5392397" y="5372305"/>
            <a:ext cx="10062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1" name="CuadroTexto 130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3747690" y="4458976"/>
            <a:ext cx="1779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4" name="CuadroTexto 133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4066140" y="3866900"/>
            <a:ext cx="1779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5" name="CuadroTexto 134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5638709" y="4495141"/>
            <a:ext cx="1779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CF907D1B-DA44-C086-4584-BAC81A0E833B}"/>
              </a:ext>
            </a:extLst>
          </p:cNvPr>
          <p:cNvSpPr txBox="1"/>
          <p:nvPr/>
        </p:nvSpPr>
        <p:spPr>
          <a:xfrm>
            <a:off x="5883173" y="3871187"/>
            <a:ext cx="1779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14962943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8F96959341DC44ACC07BE7930747C5" ma:contentTypeVersion="16" ma:contentTypeDescription="Crear nuevo documento." ma:contentTypeScope="" ma:versionID="2eaba2a1d388e081d2d0f94468dad096">
  <xsd:schema xmlns:xsd="http://www.w3.org/2001/XMLSchema" xmlns:xs="http://www.w3.org/2001/XMLSchema" xmlns:p="http://schemas.microsoft.com/office/2006/metadata/properties" xmlns:ns3="8b32a2f3-31cc-4627-876f-bbb3bae2533e" xmlns:ns4="24ccf71b-f436-409d-8863-79d1e6494e04" targetNamespace="http://schemas.microsoft.com/office/2006/metadata/properties" ma:root="true" ma:fieldsID="6738a71c16d081722b1ed99a2c8802fb" ns3:_="" ns4:_="">
    <xsd:import namespace="8b32a2f3-31cc-4627-876f-bbb3bae2533e"/>
    <xsd:import namespace="24ccf71b-f436-409d-8863-79d1e6494e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Location" minOccurs="0"/>
                <xsd:element ref="ns3:MediaServiceSystemTag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32a2f3-31cc-4627-876f-bbb3bae253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ccf71b-f436-409d-8863-79d1e6494e04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3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b32a2f3-31cc-4627-876f-bbb3bae2533e" xsi:nil="true"/>
  </documentManagement>
</p:properties>
</file>

<file path=customXml/itemProps1.xml><?xml version="1.0" encoding="utf-8"?>
<ds:datastoreItem xmlns:ds="http://schemas.openxmlformats.org/officeDocument/2006/customXml" ds:itemID="{5520226C-EA18-4A77-A902-19CE3A5A64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32a2f3-31cc-4627-876f-bbb3bae2533e"/>
    <ds:schemaRef ds:uri="24ccf71b-f436-409d-8863-79d1e6494e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34C93E9-3139-4711-98AD-D36D6ACB18B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B66D31B-72AD-4EA6-AF35-C29F36339492}">
  <ds:schemaRefs>
    <ds:schemaRef ds:uri="8b32a2f3-31cc-4627-876f-bbb3bae2533e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24ccf71b-f436-409d-8863-79d1e6494e04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40</Words>
  <Application>Microsoft Office PowerPoint</Application>
  <PresentationFormat>A4 (210 x 297 mm)</PresentationFormat>
  <Paragraphs>54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10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eronica TORRANO</dc:creator>
  <cp:lastModifiedBy>VERONICA TORRANO MOYA</cp:lastModifiedBy>
  <cp:revision>4</cp:revision>
  <dcterms:created xsi:type="dcterms:W3CDTF">2025-04-03T06:39:25Z</dcterms:created>
  <dcterms:modified xsi:type="dcterms:W3CDTF">2025-04-03T06:41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8F96959341DC44ACC07BE7930747C5</vt:lpwstr>
  </property>
</Properties>
</file>